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1" d="100"/>
          <a:sy n="121" d="100"/>
        </p:scale>
        <p:origin x="-1834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1317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2298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9210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740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6648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795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3868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6243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9455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6349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0807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5C903-A6E5-48B5-B1F1-AC9E6CC539AE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D41A7-62F4-4119-A831-9DA8E711AD4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128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1691332"/>
              </p:ext>
            </p:extLst>
          </p:nvPr>
        </p:nvGraphicFramePr>
        <p:xfrm>
          <a:off x="1013387" y="2163131"/>
          <a:ext cx="6999605" cy="1735074"/>
        </p:xfrm>
        <a:graphic>
          <a:graphicData uri="http://schemas.openxmlformats.org/drawingml/2006/table">
            <a:tbl>
              <a:tblPr firstRow="1" firstCol="1" bandRow="1">
                <a:tableStyleId>{793D81CF-94F2-401A-BA57-92F5A7B2D0C5}</a:tableStyleId>
              </a:tblPr>
              <a:tblGrid>
                <a:gridCol w="1148715"/>
                <a:gridCol w="2880360"/>
                <a:gridCol w="2970530"/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Genes</a:t>
                      </a:r>
                      <a:endParaRPr lang="en-GB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Sense primers  (5’-3’)</a:t>
                      </a:r>
                      <a:endParaRPr lang="en-GB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Anti-sense primers  (5’-3’)</a:t>
                      </a:r>
                      <a:endParaRPr lang="en-GB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Gus B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TCTGGTGGCCTTACCTGAT</a:t>
                      </a:r>
                      <a:endParaRPr lang="en-GB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TCAGTTGTTGTCACCTTCACC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GF-β1 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GGAGCAACATGTGGAACTC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GTCAGCAGCCGGTTACCA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GFβI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GAGCTGCTTATCCCAGATTCA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GGCAGTGGAGACGTCAGATT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IL-15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cap="all">
                          <a:effectLst/>
                        </a:rPr>
                        <a:t>cagaggccaactggatagatg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cap="all">
                          <a:effectLst/>
                        </a:rPr>
                        <a:t>actgtcagtgtataaagtggtgtcaat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IL-15Rα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cap="all">
                          <a:effectLst/>
                        </a:rPr>
                        <a:t>ccagtgccaacagtagtgaca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cap="all">
                          <a:effectLst/>
                        </a:rPr>
                        <a:t>ttgggagagaaagcttctgg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MCP-1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GTTGGCTCAGCCAGATGCA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AGCCTACTCATTGGGATCATCTTG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RANTES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GAGTGACAAACACGACTGCAAGAT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TGCTTTGCCTACCTCTCCCT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IFN</a:t>
                      </a:r>
                      <a:r>
                        <a:rPr lang="en-US" sz="1100">
                          <a:effectLst/>
                          <a:sym typeface="Symbol"/>
                        </a:rPr>
                        <a:t></a:t>
                      </a:r>
                      <a:endParaRPr lang="en-GB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GGCATAGATGTGGAAGAAAAGAG</a:t>
                      </a:r>
                      <a:endParaRPr lang="en-GB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GCAGGATTTTCATGTCACCAT</a:t>
                      </a:r>
                      <a:endParaRPr lang="en-GB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269238" y="4098306"/>
            <a:ext cx="65168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latin typeface="Palatino Linotype" pitchFamily="18" charset="0"/>
              </a:rPr>
              <a:t>Table S1</a:t>
            </a:r>
            <a:r>
              <a:rPr lang="en-US" sz="1200" b="1" dirty="0">
                <a:latin typeface="Palatino Linotype" pitchFamily="18" charset="0"/>
              </a:rPr>
              <a:t>. </a:t>
            </a:r>
            <a:r>
              <a:rPr lang="en-GB" sz="1200" dirty="0">
                <a:latin typeface="Palatino Linotype" pitchFamily="18" charset="0"/>
              </a:rPr>
              <a:t>Sequences of primers used for real-time quantitative PCR amplification</a:t>
            </a:r>
          </a:p>
        </p:txBody>
      </p:sp>
    </p:spTree>
    <p:extLst>
      <p:ext uri="{BB962C8B-B14F-4D97-AF65-F5344CB8AC3E}">
        <p14:creationId xmlns:p14="http://schemas.microsoft.com/office/powerpoint/2010/main" val="26663650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Affichage à l'écran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IRON-MICHEL</dc:creator>
  <cp:lastModifiedBy>GIRON-MICHEL</cp:lastModifiedBy>
  <cp:revision>2</cp:revision>
  <dcterms:created xsi:type="dcterms:W3CDTF">2021-10-27T15:36:41Z</dcterms:created>
  <dcterms:modified xsi:type="dcterms:W3CDTF">2021-10-28T12:23:32Z</dcterms:modified>
</cp:coreProperties>
</file>